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5940"/>
  </p:normalViewPr>
  <p:slideViewPr>
    <p:cSldViewPr snapToGrid="0">
      <p:cViewPr varScale="1">
        <p:scale>
          <a:sx n="88" d="100"/>
          <a:sy n="88" d="100"/>
        </p:scale>
        <p:origin x="184" y="6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E31C10-02D5-CD08-C7C9-28C42D6D7F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0B1E655-1222-43D3-CC73-063B044DC5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EC7379-CEEB-F0CE-E7F8-BF241C37C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D49C92-2E66-858D-4258-B056C9C96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25ECF7-05C9-2F33-D9C1-D4839BB0B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450703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19B00F-A5DA-96DA-0CFD-6F13AF0F4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485D11-C74B-4171-7DF6-20864BB176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D184FF-F3BF-D2C3-53D1-BA1A9B51E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302E13-2518-9987-57F9-AD95EA18C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04926F-37D7-EC39-B8CB-9262E685A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92735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97B0558-1978-53D8-32BD-CF2E23D6C0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B62032-2860-7FAE-9A7A-B6151098FB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8474FD-DC69-FFE1-BCD5-204ECA38F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7F932F-BB10-A758-359B-F1FCCDFD9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BE262B-4FCC-D6DD-AEA7-704547894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20434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DC1B09-DCFD-EEA1-7A80-19082F84F2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73112A-934D-8764-1B83-1C3FFDF2D2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CB9365-C2FE-9802-16AC-5E0CEC472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7BF78B-3FC6-DCE2-AE5B-C561FF680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211F53-06A5-9482-3173-1138CE260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16180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E7570D-114A-4E16-FB09-531A97F1D2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87E261-0F14-9A49-ADF2-F21474AD56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B8284D-06BA-4F03-E2D8-BC85BDE1AD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2AE523-F263-3B60-0F72-04F084432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D1B4F2-B9F8-59E1-F1A0-0C922B0ED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106181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AF64C-15AC-9280-1EC6-8B12C8E2DC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24B8E6-139B-AAFE-465C-C3730D8CC4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0FAECB-6DDE-FC4D-B7EF-13106A56AC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D8A89B-8658-B3A1-30C3-3C05875E0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FFA4C7-AB6D-2671-F7D0-F92289FAA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E72F1C-F315-1F2D-7365-EBF78725E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314620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7D597-85E3-C398-C21C-4F4988A84E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3D3681-7DD4-B630-5D04-04259F149B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9126A7-B458-CD34-E954-16B9AD212F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0DAD35-CFE8-0C6E-C60E-C3E7AEEB0C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B2598A7-1AE6-D539-3C18-2131FBB550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B94C31-A64B-B4E2-20F4-8CD0141F8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6396B0-E089-2F73-E177-327C6CB03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586D91-E556-14F3-F95C-285609975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437066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9390DD-4946-3DD9-30AD-36C909E170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9F4766-6619-FD3B-A052-9FE6E12BD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7E1BB9-B9E8-9BCD-F6C5-46D0508AF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3716B0-661D-BBA5-DE94-0E40B9769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54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FD9BFE3-981D-96F2-3AAA-0A8A2BC81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81F13A3-5A6A-E41D-7451-656EB9183E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B5D85EC-E116-87E5-5D89-0C8BCF1F6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410562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B7859-895C-F91E-3E60-D15196CCE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B79C04-4288-192B-3C6F-BA50D67D37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81C7BA-1487-8915-7478-68CCEEAE26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F23E52-406A-77C1-DFC4-AEE619BE2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B85FA5-71A6-AD48-9DC1-6EAD96F9A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F1265F-DEAF-FFB4-6D65-B09C1E9FB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15459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D0B1D9-69CF-7693-3BA3-73A2CDD80D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8B62C5-D322-1EE1-5FA8-CDE36C0642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8CDD00-88DE-8124-DFDA-F4EB894B48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80FACF-2B18-9BEE-345F-16F1C6219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915E7D-5D76-5EE2-5656-C12F1491A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E666D6-215A-B68A-5908-ED6C0714BC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21802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B5BFE72-20C6-DB9F-D11D-2C09F209E6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864C80-FCF7-0BC8-2A4E-43AEDE8843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3CC883-453F-0FE6-B130-4FD29F4ED2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36BE2-65F1-AB44-81D8-974B5A98D734}" type="datetimeFigureOut">
              <a:rPr lang="en-JP" smtClean="0"/>
              <a:t>2022/12/07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A24C4-98A7-08A3-9FC8-D2F4073C13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45F535-AB44-30B5-AAE5-47B7E5E218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2A3C1-20AC-B642-A81C-732919258D7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51650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1E7C5BA6-F383-4ECF-62E7-12DE32F365E7}"/>
              </a:ext>
            </a:extLst>
          </p:cNvPr>
          <p:cNvGraphicFramePr>
            <a:graphicFrameLocks/>
          </p:cNvGraphicFramePr>
          <p:nvPr/>
        </p:nvGraphicFramePr>
        <p:xfrm>
          <a:off x="486227" y="529929"/>
          <a:ext cx="11219546" cy="6210224"/>
        </p:xfrm>
        <a:graphic>
          <a:graphicData uri="http://schemas.openxmlformats.org/drawingml/2006/table">
            <a:tbl>
              <a:tblPr/>
              <a:tblGrid>
                <a:gridCol w="1677923">
                  <a:extLst>
                    <a:ext uri="{9D8B030D-6E8A-4147-A177-3AD203B41FA5}">
                      <a16:colId xmlns:a16="http://schemas.microsoft.com/office/drawing/2014/main" val="4240916917"/>
                    </a:ext>
                  </a:extLst>
                </a:gridCol>
                <a:gridCol w="1677923">
                  <a:extLst>
                    <a:ext uri="{9D8B030D-6E8A-4147-A177-3AD203B41FA5}">
                      <a16:colId xmlns:a16="http://schemas.microsoft.com/office/drawing/2014/main" val="436468218"/>
                    </a:ext>
                  </a:extLst>
                </a:gridCol>
                <a:gridCol w="1677923">
                  <a:extLst>
                    <a:ext uri="{9D8B030D-6E8A-4147-A177-3AD203B41FA5}">
                      <a16:colId xmlns:a16="http://schemas.microsoft.com/office/drawing/2014/main" val="4050595870"/>
                    </a:ext>
                  </a:extLst>
                </a:gridCol>
                <a:gridCol w="576004">
                  <a:extLst>
                    <a:ext uri="{9D8B030D-6E8A-4147-A177-3AD203B41FA5}">
                      <a16:colId xmlns:a16="http://schemas.microsoft.com/office/drawing/2014/main" val="3280555464"/>
                    </a:ext>
                  </a:extLst>
                </a:gridCol>
                <a:gridCol w="1677923">
                  <a:extLst>
                    <a:ext uri="{9D8B030D-6E8A-4147-A177-3AD203B41FA5}">
                      <a16:colId xmlns:a16="http://schemas.microsoft.com/office/drawing/2014/main" val="3441342401"/>
                    </a:ext>
                  </a:extLst>
                </a:gridCol>
                <a:gridCol w="1677923">
                  <a:extLst>
                    <a:ext uri="{9D8B030D-6E8A-4147-A177-3AD203B41FA5}">
                      <a16:colId xmlns:a16="http://schemas.microsoft.com/office/drawing/2014/main" val="2245788635"/>
                    </a:ext>
                  </a:extLst>
                </a:gridCol>
                <a:gridCol w="576004">
                  <a:extLst>
                    <a:ext uri="{9D8B030D-6E8A-4147-A177-3AD203B41FA5}">
                      <a16:colId xmlns:a16="http://schemas.microsoft.com/office/drawing/2014/main" val="3755969485"/>
                    </a:ext>
                  </a:extLst>
                </a:gridCol>
                <a:gridCol w="1677923">
                  <a:extLst>
                    <a:ext uri="{9D8B030D-6E8A-4147-A177-3AD203B41FA5}">
                      <a16:colId xmlns:a16="http://schemas.microsoft.com/office/drawing/2014/main" val="3373669263"/>
                    </a:ext>
                  </a:extLst>
                </a:gridCol>
              </a:tblGrid>
              <a:tr h="388139">
                <a:tc gridSpan="2">
                  <a:txBody>
                    <a:bodyPr/>
                    <a:lstStyle/>
                    <a:p>
                      <a:pPr algn="ctr" fontAlgn="ctr"/>
                      <a:endParaRPr lang="en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OA (N=75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A (N=29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5687724"/>
                  </a:ext>
                </a:extLst>
              </a:tr>
              <a:tr h="388139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8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6735710"/>
                  </a:ext>
                </a:extLst>
              </a:tr>
              <a:tr h="388139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 (M/F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1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705942"/>
                  </a:ext>
                </a:extLst>
              </a:tr>
              <a:tr h="388139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9979868"/>
                  </a:ext>
                </a:extLst>
              </a:tr>
              <a:tr h="388139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B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2918212"/>
                  </a:ext>
                </a:extLst>
              </a:tr>
              <a:tr h="388139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I-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8953414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 KOO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pto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7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8367935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8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5223836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O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5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7394839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3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7584990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ort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5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7800629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O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pto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694398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8309031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O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1828515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9722750"/>
                  </a:ext>
                </a:extLst>
              </a:tr>
              <a:tr h="388139"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ort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195382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B0175E9-CCC3-3C31-A036-7C5FEFD7E873}"/>
              </a:ext>
            </a:extLst>
          </p:cNvPr>
          <p:cNvSpPr txBox="1"/>
          <p:nvPr/>
        </p:nvSpPr>
        <p:spPr>
          <a:xfrm>
            <a:off x="486227" y="117847"/>
            <a:ext cx="11141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: Comparison of demographic data between excluded non-OA subjects and included OA subjects</a:t>
            </a:r>
          </a:p>
        </p:txBody>
      </p:sp>
    </p:spTree>
    <p:extLst>
      <p:ext uri="{BB962C8B-B14F-4D97-AF65-F5344CB8AC3E}">
        <p14:creationId xmlns:p14="http://schemas.microsoft.com/office/powerpoint/2010/main" val="2125687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70</Words>
  <Application>Microsoft Macintosh PowerPoint</Application>
  <PresentationFormat>Widescreen</PresentationFormat>
  <Paragraphs>1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isuke Chiba</dc:creator>
  <cp:lastModifiedBy>Daisuke Chiba</cp:lastModifiedBy>
  <cp:revision>1</cp:revision>
  <dcterms:created xsi:type="dcterms:W3CDTF">2022-12-07T02:59:11Z</dcterms:created>
  <dcterms:modified xsi:type="dcterms:W3CDTF">2022-12-07T03:00:29Z</dcterms:modified>
</cp:coreProperties>
</file>